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9" r:id="rId2"/>
    <p:sldId id="274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7986" autoAdjust="0"/>
    <p:restoredTop sz="92955" autoAdjust="0"/>
  </p:normalViewPr>
  <p:slideViewPr>
    <p:cSldViewPr snapToGrid="0">
      <p:cViewPr varScale="1">
        <p:scale>
          <a:sx n="92" d="100"/>
          <a:sy n="92" d="100"/>
        </p:scale>
        <p:origin x="121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4015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107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513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355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6159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79139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900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90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775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087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268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47F2DD-BB51-4F18-BE79-216ECE3B1BC7}" type="datetimeFigureOut">
              <a:rPr lang="en-US" smtClean="0"/>
              <a:t>12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F94EF-07C7-4509-A70B-E9070A414F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617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857" y="413023"/>
            <a:ext cx="2322786" cy="186458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8321" y="399382"/>
            <a:ext cx="2356772" cy="189186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858" y="4392718"/>
            <a:ext cx="2322786" cy="189186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8322" y="2391299"/>
            <a:ext cx="2356772" cy="1891862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8322" y="4392718"/>
            <a:ext cx="2356772" cy="189186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4857" y="2391297"/>
            <a:ext cx="2322786" cy="189186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07236" y="263599"/>
            <a:ext cx="2647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u="sng" dirty="0"/>
              <a:t>Supplemental Figure S-1</a:t>
            </a:r>
            <a:endParaRPr lang="en-US" b="1" u="sng" dirty="0"/>
          </a:p>
        </p:txBody>
      </p:sp>
      <p:grpSp>
        <p:nvGrpSpPr>
          <p:cNvPr id="9" name="Group 8"/>
          <p:cNvGrpSpPr/>
          <p:nvPr/>
        </p:nvGrpSpPr>
        <p:grpSpPr>
          <a:xfrm>
            <a:off x="3771415" y="389654"/>
            <a:ext cx="374646" cy="400110"/>
            <a:chOff x="479777" y="1733317"/>
            <a:chExt cx="374646" cy="400110"/>
          </a:xfrm>
        </p:grpSpPr>
        <p:sp>
          <p:nvSpPr>
            <p:cNvPr id="12" name="Rectangle 11"/>
            <p:cNvSpPr/>
            <p:nvPr/>
          </p:nvSpPr>
          <p:spPr>
            <a:xfrm>
              <a:off x="479777" y="1756455"/>
              <a:ext cx="371475" cy="35242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83809" y="1733317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5" name="Group 14"/>
          <p:cNvGrpSpPr/>
          <p:nvPr/>
        </p:nvGrpSpPr>
        <p:grpSpPr>
          <a:xfrm>
            <a:off x="6195150" y="369793"/>
            <a:ext cx="379676" cy="400110"/>
            <a:chOff x="479777" y="1743045"/>
            <a:chExt cx="379676" cy="400110"/>
          </a:xfrm>
        </p:grpSpPr>
        <p:sp>
          <p:nvSpPr>
            <p:cNvPr id="16" name="Rectangle 15"/>
            <p:cNvSpPr/>
            <p:nvPr/>
          </p:nvSpPr>
          <p:spPr>
            <a:xfrm>
              <a:off x="479777" y="1756455"/>
              <a:ext cx="371475" cy="35242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3265" y="1743045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3772810" y="2366623"/>
            <a:ext cx="371475" cy="400110"/>
            <a:chOff x="479777" y="1733373"/>
            <a:chExt cx="371475" cy="400110"/>
          </a:xfrm>
        </p:grpSpPr>
        <p:sp>
          <p:nvSpPr>
            <p:cNvPr id="19" name="Rectangle 18"/>
            <p:cNvSpPr/>
            <p:nvPr/>
          </p:nvSpPr>
          <p:spPr>
            <a:xfrm>
              <a:off x="479777" y="1756455"/>
              <a:ext cx="371475" cy="35242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80638" y="1733373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6193929" y="2379430"/>
            <a:ext cx="394102" cy="402419"/>
            <a:chOff x="479777" y="1743045"/>
            <a:chExt cx="394102" cy="365835"/>
          </a:xfrm>
        </p:grpSpPr>
        <p:sp>
          <p:nvSpPr>
            <p:cNvPr id="22" name="Rectangle 21"/>
            <p:cNvSpPr/>
            <p:nvPr/>
          </p:nvSpPr>
          <p:spPr>
            <a:xfrm>
              <a:off x="479777" y="1756455"/>
              <a:ext cx="371475" cy="35242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03265" y="1743045"/>
              <a:ext cx="370614" cy="3637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3771415" y="4386074"/>
            <a:ext cx="386888" cy="400110"/>
            <a:chOff x="479777" y="1743045"/>
            <a:chExt cx="386888" cy="400110"/>
          </a:xfrm>
        </p:grpSpPr>
        <p:sp>
          <p:nvSpPr>
            <p:cNvPr id="25" name="Rectangle 24"/>
            <p:cNvSpPr/>
            <p:nvPr/>
          </p:nvSpPr>
          <p:spPr>
            <a:xfrm>
              <a:off x="479777" y="1756455"/>
              <a:ext cx="371475" cy="35242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10478" y="1743045"/>
              <a:ext cx="3561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CA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7" name="Group 26"/>
          <p:cNvGrpSpPr/>
          <p:nvPr/>
        </p:nvGrpSpPr>
        <p:grpSpPr>
          <a:xfrm>
            <a:off x="6199681" y="4383216"/>
            <a:ext cx="371475" cy="400110"/>
            <a:chOff x="479777" y="1743045"/>
            <a:chExt cx="371475" cy="400110"/>
          </a:xfrm>
        </p:grpSpPr>
        <p:sp>
          <p:nvSpPr>
            <p:cNvPr id="28" name="Rectangle 27"/>
            <p:cNvSpPr/>
            <p:nvPr/>
          </p:nvSpPr>
          <p:spPr>
            <a:xfrm>
              <a:off x="479777" y="1756455"/>
              <a:ext cx="371475" cy="35242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03265" y="1743045"/>
              <a:ext cx="34176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5" name="Straight Connector 4"/>
          <p:cNvCxnSpPr/>
          <p:nvPr/>
        </p:nvCxnSpPr>
        <p:spPr>
          <a:xfrm>
            <a:off x="6350920" y="2062261"/>
            <a:ext cx="428017" cy="194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917000" y="2042806"/>
            <a:ext cx="428017" cy="194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896303" y="4082372"/>
            <a:ext cx="428017" cy="194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>
            <a:off x="6318883" y="4104753"/>
            <a:ext cx="428017" cy="194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3904789" y="6057086"/>
            <a:ext cx="428017" cy="194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6310768" y="6076541"/>
            <a:ext cx="428017" cy="19455"/>
          </a:xfrm>
          <a:prstGeom prst="line">
            <a:avLst/>
          </a:prstGeom>
          <a:ln w="254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99826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25024" y="1513291"/>
            <a:ext cx="7602601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Figure S-1. Light photomicrograph of the sample from a participant containing fibrous and cartilaginous tissues (A) and a collection of cartilaginous pieces from the same sample (B) with all fibrous tissue removed. Phase contrast photomicrographs showing details of the collagenase digestion process: (C) 0 hour, (D) 1 hour – evidence of digested cartilage with a few chondrocytes on the left side of the tissue, (E) 4 hours – many chondrocytes are present in the digested cartilage, and (F) 18 hours – only isolated chondrocytes are evident. Scale bar = 2 mm.</a:t>
            </a:r>
            <a:endParaRPr lang="en-CA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07235" y="263599"/>
            <a:ext cx="2561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u="sng" dirty="0"/>
              <a:t>Supplemental Figure S-1</a:t>
            </a:r>
            <a:endParaRPr lang="en-US" b="1" u="sng" dirty="0"/>
          </a:p>
        </p:txBody>
      </p:sp>
    </p:spTree>
    <p:extLst>
      <p:ext uri="{BB962C8B-B14F-4D97-AF65-F5344CB8AC3E}">
        <p14:creationId xmlns:p14="http://schemas.microsoft.com/office/powerpoint/2010/main" val="22881356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7</TotalTime>
  <Words>123</Words>
  <Application>Microsoft Office PowerPoint</Application>
  <PresentationFormat>On-screen Show (4:3)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Pang</dc:creator>
  <cp:lastModifiedBy>Stephen C Pang</cp:lastModifiedBy>
  <cp:revision>32</cp:revision>
  <dcterms:created xsi:type="dcterms:W3CDTF">2023-05-24T12:52:34Z</dcterms:created>
  <dcterms:modified xsi:type="dcterms:W3CDTF">2023-12-29T19:08:02Z</dcterms:modified>
</cp:coreProperties>
</file>